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96"/>
  </p:normalViewPr>
  <p:slideViewPr>
    <p:cSldViewPr snapToGrid="0" snapToObjects="1">
      <p:cViewPr varScale="1">
        <p:scale>
          <a:sx n="111" d="100"/>
          <a:sy n="111" d="100"/>
        </p:scale>
        <p:origin x="14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781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656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5261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997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41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9472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751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7522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435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248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8731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41E85-AA26-C14E-BBFD-C84ACA449CF3}" type="datetimeFigureOut">
              <a:rPr lang="fr-FR" smtClean="0"/>
              <a:t>02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5A3AF-2F5A-9C4A-97C5-DD9B772FA8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67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58210C7D-F7C9-3A4F-BACD-BF500CE82338}"/>
              </a:ext>
            </a:extLst>
          </p:cNvPr>
          <p:cNvGrpSpPr/>
          <p:nvPr/>
        </p:nvGrpSpPr>
        <p:grpSpPr>
          <a:xfrm>
            <a:off x="286484" y="134796"/>
            <a:ext cx="4666560" cy="2946197"/>
            <a:chOff x="726564" y="3521574"/>
            <a:chExt cx="4666560" cy="2946197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6665A84A-162C-CF41-BA34-F972859394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699" t="56541" r="14213" b="27512"/>
            <a:stretch/>
          </p:blipFill>
          <p:spPr>
            <a:xfrm>
              <a:off x="726564" y="4587978"/>
              <a:ext cx="3077517" cy="4031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DE9F6BAA-CB53-294B-8921-F75323A033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835" t="48633" r="13136" b="35051"/>
            <a:stretch/>
          </p:blipFill>
          <p:spPr>
            <a:xfrm>
              <a:off x="731509" y="6092885"/>
              <a:ext cx="3085889" cy="3748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1474DE40-E5A9-684D-95AB-208AED5690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558" t="25028" r="14982" b="37155"/>
            <a:stretch/>
          </p:blipFill>
          <p:spPr>
            <a:xfrm>
              <a:off x="726564" y="5082465"/>
              <a:ext cx="3085889" cy="9465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64C31AA5-0CD1-864A-ABBF-ABDD59C0B55B}"/>
                </a:ext>
              </a:extLst>
            </p:cNvPr>
            <p:cNvSpPr txBox="1"/>
            <p:nvPr/>
          </p:nvSpPr>
          <p:spPr>
            <a:xfrm>
              <a:off x="3827172" y="5323396"/>
              <a:ext cx="15659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29EBC7D-ECFB-9948-B173-53D3C146F01F}"/>
                </a:ext>
              </a:extLst>
            </p:cNvPr>
            <p:cNvSpPr txBox="1"/>
            <p:nvPr/>
          </p:nvSpPr>
          <p:spPr>
            <a:xfrm>
              <a:off x="3827172" y="4633837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rP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5C8A5CBB-E400-D342-89D4-1C7BED3DEEC1}"/>
                </a:ext>
              </a:extLst>
            </p:cNvPr>
            <p:cNvSpPr txBox="1"/>
            <p:nvPr/>
          </p:nvSpPr>
          <p:spPr>
            <a:xfrm>
              <a:off x="3827172" y="6141941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-Tu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1339B58E-26F0-8649-B743-9E1D6ED64886}"/>
                </a:ext>
              </a:extLst>
            </p:cNvPr>
            <p:cNvSpPr txBox="1"/>
            <p:nvPr/>
          </p:nvSpPr>
          <p:spPr>
            <a:xfrm rot="18936121">
              <a:off x="2375309" y="3989799"/>
              <a:ext cx="120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dsN</a:t>
              </a:r>
              <a:r>
                <a:rPr lang="fr-FR" sz="14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7-1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7923F31B-EA08-E048-9A6D-B862AA2B52B4}"/>
                </a:ext>
              </a:extLst>
            </p:cNvPr>
            <p:cNvSpPr txBox="1"/>
            <p:nvPr/>
          </p:nvSpPr>
          <p:spPr>
            <a:xfrm rot="18724818">
              <a:off x="1105262" y="4131262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prA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F78511D0-3A20-CE48-BA9F-2A51B5B60473}"/>
                </a:ext>
              </a:extLst>
            </p:cNvPr>
            <p:cNvSpPr txBox="1"/>
            <p:nvPr/>
          </p:nvSpPr>
          <p:spPr>
            <a:xfrm rot="18684069">
              <a:off x="677041" y="4044311"/>
              <a:ext cx="10033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Rplac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7BEFE6F6-5234-B746-98C7-1AE35994C0D2}"/>
                </a:ext>
              </a:extLst>
            </p:cNvPr>
            <p:cNvSpPr txBox="1"/>
            <p:nvPr/>
          </p:nvSpPr>
          <p:spPr>
            <a:xfrm rot="18734821">
              <a:off x="1430729" y="3971754"/>
              <a:ext cx="120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prAmut2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1307A3AA-9126-E744-98E5-9B7C495E08C3}"/>
                </a:ext>
              </a:extLst>
            </p:cNvPr>
            <p:cNvSpPr txBox="1"/>
            <p:nvPr/>
          </p:nvSpPr>
          <p:spPr>
            <a:xfrm rot="18915375">
              <a:off x="1959392" y="4042730"/>
              <a:ext cx="10522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dsN</a:t>
              </a:r>
              <a:r>
                <a:rPr lang="fr-FR" sz="14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7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48B96391-DDF7-394A-9F0E-0A7AE7874984}"/>
                </a:ext>
              </a:extLst>
            </p:cNvPr>
            <p:cNvSpPr txBox="1"/>
            <p:nvPr/>
          </p:nvSpPr>
          <p:spPr>
            <a:xfrm>
              <a:off x="3383889" y="4332985"/>
              <a:ext cx="5025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</a:t>
              </a:r>
              <a:r>
                <a:rPr lang="fr-FR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B49D1C74-8688-A24E-A9FA-4CBB0CF4C6E8}"/>
                </a:ext>
              </a:extLst>
            </p:cNvPr>
            <p:cNvSpPr txBox="1"/>
            <p:nvPr/>
          </p:nvSpPr>
          <p:spPr>
            <a:xfrm rot="19004598">
              <a:off x="2824613" y="3977301"/>
              <a:ext cx="11961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rP</a:t>
              </a:r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 flag</a:t>
              </a:r>
            </a:p>
          </p:txBody>
        </p:sp>
      </p:grpSp>
      <p:sp>
        <p:nvSpPr>
          <p:cNvPr id="18" name="ZoneTexte 17">
            <a:extLst>
              <a:ext uri="{FF2B5EF4-FFF2-40B4-BE49-F238E27FC236}">
                <a16:creationId xmlns:a16="http://schemas.microsoft.com/office/drawing/2014/main" id="{B2191AB1-DA25-0A44-876A-552CC84B48F4}"/>
              </a:ext>
            </a:extLst>
          </p:cNvPr>
          <p:cNvSpPr txBox="1"/>
          <p:nvPr/>
        </p:nvSpPr>
        <p:spPr>
          <a:xfrm>
            <a:off x="6995024" y="5587782"/>
            <a:ext cx="119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D0D84BC-829C-A64A-A62C-A5F621D7C109}"/>
              </a:ext>
            </a:extLst>
          </p:cNvPr>
          <p:cNvSpPr txBox="1"/>
          <p:nvPr/>
        </p:nvSpPr>
        <p:spPr>
          <a:xfrm>
            <a:off x="334636" y="41787"/>
            <a:ext cx="5592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18DDBEC8-91CB-214F-B80B-971D6A232976}"/>
              </a:ext>
            </a:extLst>
          </p:cNvPr>
          <p:cNvSpPr txBox="1"/>
          <p:nvPr/>
        </p:nvSpPr>
        <p:spPr>
          <a:xfrm rot="19004598">
            <a:off x="7018326" y="418541"/>
            <a:ext cx="1476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rP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 flag</a:t>
            </a:r>
          </a:p>
        </p:txBody>
      </p:sp>
      <p:pic>
        <p:nvPicPr>
          <p:cNvPr id="21" name="Image 20">
            <a:extLst>
              <a:ext uri="{FF2B5EF4-FFF2-40B4-BE49-F238E27FC236}">
                <a16:creationId xmlns:a16="http://schemas.microsoft.com/office/drawing/2014/main" id="{F9C0CE13-F9D2-1948-AAB8-99EA62E21D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66870" y="1197222"/>
            <a:ext cx="2786200" cy="10431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79DC715A-64C5-AB4C-9EF5-9B350AE5EF9C}"/>
              </a:ext>
            </a:extLst>
          </p:cNvPr>
          <p:cNvSpPr txBox="1"/>
          <p:nvPr/>
        </p:nvSpPr>
        <p:spPr>
          <a:xfrm rot="18936121">
            <a:off x="6607170" y="527249"/>
            <a:ext cx="1208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sN</a:t>
            </a:r>
            <a:r>
              <a:rPr lang="fr-FR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7-1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BD67CB3-4DDD-9447-BE7F-765CA1DD4C53}"/>
              </a:ext>
            </a:extLst>
          </p:cNvPr>
          <p:cNvSpPr txBox="1"/>
          <p:nvPr/>
        </p:nvSpPr>
        <p:spPr>
          <a:xfrm rot="18724818">
            <a:off x="5337123" y="668712"/>
            <a:ext cx="7760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prA</a:t>
            </a:r>
            <a:endParaRPr lang="fr-F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B760A120-65ED-B941-8678-CD49060B429B}"/>
              </a:ext>
            </a:extLst>
          </p:cNvPr>
          <p:cNvSpPr txBox="1"/>
          <p:nvPr/>
        </p:nvSpPr>
        <p:spPr>
          <a:xfrm rot="18684069">
            <a:off x="4908902" y="581761"/>
            <a:ext cx="10033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Rplac</a:t>
            </a:r>
            <a:endParaRPr lang="fr-F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5585BB66-D8C4-A54A-A021-CB9CA023C80E}"/>
              </a:ext>
            </a:extLst>
          </p:cNvPr>
          <p:cNvSpPr txBox="1"/>
          <p:nvPr/>
        </p:nvSpPr>
        <p:spPr>
          <a:xfrm rot="18734821">
            <a:off x="5662590" y="509204"/>
            <a:ext cx="1208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prAmut2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587424E6-EFFA-0A48-9463-AA0A5F448B43}"/>
              </a:ext>
            </a:extLst>
          </p:cNvPr>
          <p:cNvSpPr txBox="1"/>
          <p:nvPr/>
        </p:nvSpPr>
        <p:spPr>
          <a:xfrm rot="18915375">
            <a:off x="6191253" y="580180"/>
            <a:ext cx="10522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sN</a:t>
            </a:r>
            <a:r>
              <a:rPr lang="fr-FR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7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02F5715A-E91C-FB41-9471-B3FE9A0AE244}"/>
              </a:ext>
            </a:extLst>
          </p:cNvPr>
          <p:cNvSpPr txBox="1"/>
          <p:nvPr/>
        </p:nvSpPr>
        <p:spPr>
          <a:xfrm>
            <a:off x="7615750" y="870435"/>
            <a:ext cx="5025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O</a:t>
            </a:r>
            <a:r>
              <a:rPr lang="fr-FR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38B6BA08-5EC9-9442-96E4-051E4E93CA4E}"/>
              </a:ext>
            </a:extLst>
          </p:cNvPr>
          <p:cNvGrpSpPr/>
          <p:nvPr/>
        </p:nvGrpSpPr>
        <p:grpSpPr>
          <a:xfrm>
            <a:off x="7927142" y="1150865"/>
            <a:ext cx="1039611" cy="1683720"/>
            <a:chOff x="2523200" y="4051252"/>
            <a:chExt cx="1039611" cy="1683720"/>
          </a:xfrm>
        </p:grpSpPr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C3359934-641E-0B43-BFA7-B05FFCA29150}"/>
                </a:ext>
              </a:extLst>
            </p:cNvPr>
            <p:cNvSpPr txBox="1"/>
            <p:nvPr/>
          </p:nvSpPr>
          <p:spPr>
            <a:xfrm>
              <a:off x="2786780" y="5427195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-Tu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876E513E-CBD9-594A-9474-8951440DFF81}"/>
                </a:ext>
              </a:extLst>
            </p:cNvPr>
            <p:cNvSpPr txBox="1"/>
            <p:nvPr/>
          </p:nvSpPr>
          <p:spPr>
            <a:xfrm>
              <a:off x="2546152" y="4051252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flag</a:t>
              </a:r>
            </a:p>
          </p:txBody>
        </p:sp>
        <p:cxnSp>
          <p:nvCxnSpPr>
            <p:cNvPr id="31" name="Connecteur droit avec flèche 30">
              <a:extLst>
                <a:ext uri="{FF2B5EF4-FFF2-40B4-BE49-F238E27FC236}">
                  <a16:creationId xmlns:a16="http://schemas.microsoft.com/office/drawing/2014/main" id="{6C2BB3CC-2655-5841-BEFD-B61EFB9FC16E}"/>
                </a:ext>
              </a:extLst>
            </p:cNvPr>
            <p:cNvCxnSpPr/>
            <p:nvPr/>
          </p:nvCxnSpPr>
          <p:spPr>
            <a:xfrm flipH="1">
              <a:off x="2523200" y="4475783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avec flèche 31">
              <a:extLst>
                <a:ext uri="{FF2B5EF4-FFF2-40B4-BE49-F238E27FC236}">
                  <a16:creationId xmlns:a16="http://schemas.microsoft.com/office/drawing/2014/main" id="{4378AF7C-4F63-AA45-8426-F6A92BD92ADA}"/>
                </a:ext>
              </a:extLst>
            </p:cNvPr>
            <p:cNvCxnSpPr/>
            <p:nvPr/>
          </p:nvCxnSpPr>
          <p:spPr>
            <a:xfrm flipH="1">
              <a:off x="2523200" y="4792331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830AD11A-44C7-CC46-AEDB-E31F708030DF}"/>
                </a:ext>
              </a:extLst>
            </p:cNvPr>
            <p:cNvSpPr txBox="1"/>
            <p:nvPr/>
          </p:nvSpPr>
          <p:spPr>
            <a:xfrm>
              <a:off x="2717249" y="4321894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rP</a:t>
              </a:r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028B0A9E-FFDA-9040-85E7-5C45D9105EED}"/>
                </a:ext>
              </a:extLst>
            </p:cNvPr>
            <p:cNvSpPr txBox="1"/>
            <p:nvPr/>
          </p:nvSpPr>
          <p:spPr>
            <a:xfrm>
              <a:off x="2717249" y="4629671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rP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5" name="Image 34">
            <a:extLst>
              <a:ext uri="{FF2B5EF4-FFF2-40B4-BE49-F238E27FC236}">
                <a16:creationId xmlns:a16="http://schemas.microsoft.com/office/drawing/2014/main" id="{B856177C-317F-544D-849A-8BB6A4986B2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059"/>
          <a:stretch/>
        </p:blipFill>
        <p:spPr>
          <a:xfrm>
            <a:off x="5066871" y="2387129"/>
            <a:ext cx="2786200" cy="70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ZoneTexte 35">
            <a:extLst>
              <a:ext uri="{FF2B5EF4-FFF2-40B4-BE49-F238E27FC236}">
                <a16:creationId xmlns:a16="http://schemas.microsoft.com/office/drawing/2014/main" id="{E4F3720F-8B92-654B-A460-E9A7B122AD99}"/>
              </a:ext>
            </a:extLst>
          </p:cNvPr>
          <p:cNvSpPr txBox="1"/>
          <p:nvPr/>
        </p:nvSpPr>
        <p:spPr>
          <a:xfrm>
            <a:off x="4699094" y="41787"/>
            <a:ext cx="5592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FAE5C71-D585-DD4F-9659-04459833B577}"/>
              </a:ext>
            </a:extLst>
          </p:cNvPr>
          <p:cNvSpPr txBox="1"/>
          <p:nvPr/>
        </p:nvSpPr>
        <p:spPr>
          <a:xfrm>
            <a:off x="274458" y="3699209"/>
            <a:ext cx="816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grpSp>
        <p:nvGrpSpPr>
          <p:cNvPr id="38" name="Groupe 37">
            <a:extLst>
              <a:ext uri="{FF2B5EF4-FFF2-40B4-BE49-F238E27FC236}">
                <a16:creationId xmlns:a16="http://schemas.microsoft.com/office/drawing/2014/main" id="{E434CB8F-81D0-2440-A7FB-CF86B488BDD1}"/>
              </a:ext>
            </a:extLst>
          </p:cNvPr>
          <p:cNvGrpSpPr/>
          <p:nvPr/>
        </p:nvGrpSpPr>
        <p:grpSpPr>
          <a:xfrm>
            <a:off x="334636" y="3244718"/>
            <a:ext cx="4099625" cy="2957045"/>
            <a:chOff x="421492" y="3543611"/>
            <a:chExt cx="4099625" cy="2957045"/>
          </a:xfrm>
        </p:grpSpPr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4C02075D-D0B7-9445-A459-465B7AD6F302}"/>
                </a:ext>
              </a:extLst>
            </p:cNvPr>
            <p:cNvSpPr txBox="1"/>
            <p:nvPr/>
          </p:nvSpPr>
          <p:spPr>
            <a:xfrm>
              <a:off x="2790344" y="4153226"/>
              <a:ext cx="817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Rplac</a:t>
              </a:r>
              <a:endPara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1E5A51D7-A84F-ED4E-B126-890AFBD73E73}"/>
                </a:ext>
              </a:extLst>
            </p:cNvPr>
            <p:cNvSpPr txBox="1"/>
            <p:nvPr/>
          </p:nvSpPr>
          <p:spPr>
            <a:xfrm>
              <a:off x="2837138" y="4350766"/>
              <a:ext cx="5025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½*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549B8AD9-616F-9A44-886E-73187842B530}"/>
                </a:ext>
              </a:extLst>
            </p:cNvPr>
            <p:cNvSpPr txBox="1"/>
            <p:nvPr/>
          </p:nvSpPr>
          <p:spPr>
            <a:xfrm>
              <a:off x="3134200" y="4350766"/>
              <a:ext cx="5025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¼*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797AD997-7F6B-1F40-AA9D-1AAB3EEC8785}"/>
                </a:ext>
              </a:extLst>
            </p:cNvPr>
            <p:cNvSpPr txBox="1"/>
            <p:nvPr/>
          </p:nvSpPr>
          <p:spPr>
            <a:xfrm>
              <a:off x="2469153" y="4350766"/>
              <a:ext cx="5025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</a:t>
              </a:r>
              <a:r>
                <a:rPr lang="fr-FR" sz="12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pic>
          <p:nvPicPr>
            <p:cNvPr id="43" name="Image 42">
              <a:extLst>
                <a:ext uri="{FF2B5EF4-FFF2-40B4-BE49-F238E27FC236}">
                  <a16:creationId xmlns:a16="http://schemas.microsoft.com/office/drawing/2014/main" id="{BA3863D0-6DDB-E347-9DA0-BAB7E2015D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907" t="26949" r="4048" b="28525"/>
            <a:stretch/>
          </p:blipFill>
          <p:spPr>
            <a:xfrm flipH="1">
              <a:off x="421937" y="5889401"/>
              <a:ext cx="3056271" cy="6112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C0D7F75F-ABDF-0C41-B7B0-7C3792524CE3}"/>
                </a:ext>
              </a:extLst>
            </p:cNvPr>
            <p:cNvSpPr txBox="1"/>
            <p:nvPr/>
          </p:nvSpPr>
          <p:spPr>
            <a:xfrm rot="18936121">
              <a:off x="1666716" y="4011836"/>
              <a:ext cx="120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dsN</a:t>
              </a:r>
              <a:r>
                <a:rPr lang="fr-FR" sz="14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7-1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9FFC299F-E40D-D449-B206-EDB31D2D9894}"/>
                </a:ext>
              </a:extLst>
            </p:cNvPr>
            <p:cNvSpPr txBox="1"/>
            <p:nvPr/>
          </p:nvSpPr>
          <p:spPr>
            <a:xfrm rot="18724818">
              <a:off x="773744" y="4153299"/>
              <a:ext cx="7760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prA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45C94734-166C-6C4F-B19F-4C331480082F}"/>
                </a:ext>
              </a:extLst>
            </p:cNvPr>
            <p:cNvSpPr txBox="1"/>
            <p:nvPr/>
          </p:nvSpPr>
          <p:spPr>
            <a:xfrm rot="18684069">
              <a:off x="411509" y="4066348"/>
              <a:ext cx="10033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Rplac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B96BAF66-08F1-3545-A799-860168B76886}"/>
                </a:ext>
              </a:extLst>
            </p:cNvPr>
            <p:cNvSpPr txBox="1"/>
            <p:nvPr/>
          </p:nvSpPr>
          <p:spPr>
            <a:xfrm rot="18734821">
              <a:off x="1023791" y="3993791"/>
              <a:ext cx="1208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prAmut2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F82D45D4-0A49-F147-B839-722EC6980A78}"/>
                </a:ext>
              </a:extLst>
            </p:cNvPr>
            <p:cNvSpPr txBox="1"/>
            <p:nvPr/>
          </p:nvSpPr>
          <p:spPr>
            <a:xfrm rot="18915375">
              <a:off x="1345069" y="4064767"/>
              <a:ext cx="10522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dsN</a:t>
              </a:r>
              <a:r>
                <a:rPr lang="fr-FR" sz="14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7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E40BB347-039C-9745-93A7-D4E5891122B6}"/>
                </a:ext>
              </a:extLst>
            </p:cNvPr>
            <p:cNvSpPr txBox="1"/>
            <p:nvPr/>
          </p:nvSpPr>
          <p:spPr>
            <a:xfrm rot="19004598">
              <a:off x="2050031" y="3999338"/>
              <a:ext cx="11961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rP</a:t>
              </a:r>
              <a:r>
                <a: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 flag</a:t>
              </a:r>
            </a:p>
          </p:txBody>
        </p:sp>
        <p:grpSp>
          <p:nvGrpSpPr>
            <p:cNvPr id="50" name="Groupe 49">
              <a:extLst>
                <a:ext uri="{FF2B5EF4-FFF2-40B4-BE49-F238E27FC236}">
                  <a16:creationId xmlns:a16="http://schemas.microsoft.com/office/drawing/2014/main" id="{B53B8E0D-43CF-034E-B5D8-5AC2F1B7E6CB}"/>
                </a:ext>
              </a:extLst>
            </p:cNvPr>
            <p:cNvGrpSpPr/>
            <p:nvPr/>
          </p:nvGrpSpPr>
          <p:grpSpPr>
            <a:xfrm>
              <a:off x="3481506" y="4757638"/>
              <a:ext cx="1039611" cy="1683720"/>
              <a:chOff x="2523200" y="4051252"/>
              <a:chExt cx="1039611" cy="1683720"/>
            </a:xfrm>
          </p:grpSpPr>
          <p:sp>
            <p:nvSpPr>
              <p:cNvPr id="52" name="ZoneTexte 51">
                <a:extLst>
                  <a:ext uri="{FF2B5EF4-FFF2-40B4-BE49-F238E27FC236}">
                    <a16:creationId xmlns:a16="http://schemas.microsoft.com/office/drawing/2014/main" id="{0073FCCE-568F-FA45-8775-ADB1D0601B5E}"/>
                  </a:ext>
                </a:extLst>
              </p:cNvPr>
              <p:cNvSpPr txBox="1"/>
              <p:nvPr/>
            </p:nvSpPr>
            <p:spPr>
              <a:xfrm>
                <a:off x="2786780" y="5427195"/>
                <a:ext cx="776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F-Tu</a:t>
                </a:r>
              </a:p>
            </p:txBody>
          </p:sp>
          <p:sp>
            <p:nvSpPr>
              <p:cNvPr id="53" name="ZoneTexte 52">
                <a:extLst>
                  <a:ext uri="{FF2B5EF4-FFF2-40B4-BE49-F238E27FC236}">
                    <a16:creationId xmlns:a16="http://schemas.microsoft.com/office/drawing/2014/main" id="{6E73815B-F342-C247-AB96-0623EA97F125}"/>
                  </a:ext>
                </a:extLst>
              </p:cNvPr>
              <p:cNvSpPr txBox="1"/>
              <p:nvPr/>
            </p:nvSpPr>
            <p:spPr>
              <a:xfrm>
                <a:off x="2546152" y="4051252"/>
                <a:ext cx="776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r>
                  <a:rPr lang="fr-F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flag</a:t>
                </a:r>
              </a:p>
            </p:txBody>
          </p:sp>
          <p:cxnSp>
            <p:nvCxnSpPr>
              <p:cNvPr id="54" name="Connecteur droit avec flèche 53">
                <a:extLst>
                  <a:ext uri="{FF2B5EF4-FFF2-40B4-BE49-F238E27FC236}">
                    <a16:creationId xmlns:a16="http://schemas.microsoft.com/office/drawing/2014/main" id="{015F0896-4B6E-554C-88ED-7A31DE69137A}"/>
                  </a:ext>
                </a:extLst>
              </p:cNvPr>
              <p:cNvCxnSpPr/>
              <p:nvPr/>
            </p:nvCxnSpPr>
            <p:spPr>
              <a:xfrm flipH="1">
                <a:off x="2523200" y="4475783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avec flèche 54">
                <a:extLst>
                  <a:ext uri="{FF2B5EF4-FFF2-40B4-BE49-F238E27FC236}">
                    <a16:creationId xmlns:a16="http://schemas.microsoft.com/office/drawing/2014/main" id="{B99C45A9-B34D-FA4D-97B0-053AFBACEF4F}"/>
                  </a:ext>
                </a:extLst>
              </p:cNvPr>
              <p:cNvCxnSpPr/>
              <p:nvPr/>
            </p:nvCxnSpPr>
            <p:spPr>
              <a:xfrm flipH="1">
                <a:off x="2523200" y="4792331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ZoneTexte 55">
                <a:extLst>
                  <a:ext uri="{FF2B5EF4-FFF2-40B4-BE49-F238E27FC236}">
                    <a16:creationId xmlns:a16="http://schemas.microsoft.com/office/drawing/2014/main" id="{17827840-26B5-B849-B170-14D70B3878A7}"/>
                  </a:ext>
                </a:extLst>
              </p:cNvPr>
              <p:cNvSpPr txBox="1"/>
              <p:nvPr/>
            </p:nvSpPr>
            <p:spPr>
              <a:xfrm>
                <a:off x="2717249" y="4321894"/>
                <a:ext cx="776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rP</a:t>
                </a:r>
                <a:r>
                  <a:rPr lang="fr-F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</a:t>
                </a:r>
              </a:p>
            </p:txBody>
          </p:sp>
          <p:sp>
            <p:nvSpPr>
              <p:cNvPr id="57" name="ZoneTexte 56">
                <a:extLst>
                  <a:ext uri="{FF2B5EF4-FFF2-40B4-BE49-F238E27FC236}">
                    <a16:creationId xmlns:a16="http://schemas.microsoft.com/office/drawing/2014/main" id="{42A9842E-C3D6-6A43-9136-6D99221B099C}"/>
                  </a:ext>
                </a:extLst>
              </p:cNvPr>
              <p:cNvSpPr txBox="1"/>
              <p:nvPr/>
            </p:nvSpPr>
            <p:spPr>
              <a:xfrm>
                <a:off x="2717249" y="4629671"/>
                <a:ext cx="77603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rP</a:t>
                </a:r>
                <a:endPara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51" name="Image 50">
              <a:extLst>
                <a:ext uri="{FF2B5EF4-FFF2-40B4-BE49-F238E27FC236}">
                  <a16:creationId xmlns:a16="http://schemas.microsoft.com/office/drawing/2014/main" id="{5580A4B7-817F-E447-98D2-7FC99CF5F3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943" b="11171"/>
            <a:stretch/>
          </p:blipFill>
          <p:spPr>
            <a:xfrm flipH="1">
              <a:off x="421492" y="4612802"/>
              <a:ext cx="3055918" cy="12183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3617876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</Words>
  <Application>Microsoft Macintosh PowerPoint</Application>
  <PresentationFormat>Format A4 (210 x 297 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</cp:revision>
  <dcterms:created xsi:type="dcterms:W3CDTF">2020-10-02T14:24:21Z</dcterms:created>
  <dcterms:modified xsi:type="dcterms:W3CDTF">2020-10-02T14:24:48Z</dcterms:modified>
</cp:coreProperties>
</file>